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3" r:id="rId2"/>
    <p:sldId id="257" r:id="rId3"/>
    <p:sldId id="258" r:id="rId4"/>
    <p:sldId id="260" r:id="rId5"/>
    <p:sldId id="262" r:id="rId6"/>
    <p:sldId id="259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3162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image" Target="../media/image37.emf"/><Relationship Id="rId6" Type="http://schemas.openxmlformats.org/officeDocument/2006/relationships/image" Target="../media/image42.emf"/><Relationship Id="rId5" Type="http://schemas.openxmlformats.org/officeDocument/2006/relationships/image" Target="../media/image41.emf"/><Relationship Id="rId4" Type="http://schemas.openxmlformats.org/officeDocument/2006/relationships/image" Target="../media/image4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EB3D99-580A-4218-9461-4E8E1DD5DBF1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D9A465-8518-423B-A9BD-5A7F1A415B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539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28003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/>
              <a:t>Figure</a:t>
            </a:r>
            <a:r>
              <a:rPr lang="en-GB" b="1" baseline="0" dirty="0"/>
              <a:t> 5. </a:t>
            </a:r>
            <a:r>
              <a:rPr lang="en-US" sz="1400" b="1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aP</a:t>
            </a:r>
            <a:r>
              <a:rPr lang="en-US" sz="14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uce oxidative stress in AMLs</a:t>
            </a:r>
          </a:p>
          <a:p>
            <a:pPr marL="0" marR="0" lvl="0" indent="0" algn="l" defTabSz="128003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4,</a:t>
            </a:r>
            <a:r>
              <a:rPr lang="en-GB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KG1a and HL60 </a:t>
            </a:r>
            <a:r>
              <a:rPr lang="en-GB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 were treated with v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hicle control(CON),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6mM Valproate(VAL),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5 </a:t>
            </a:r>
            <a:r>
              <a:rPr lang="en-GB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EZ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5uM MPA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5mM), 0.1mM BEZ and 5uM MPA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1mM), the combination of Valproate 0.6mM and 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1mM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</a:t>
            </a:r>
            <a:r>
              <a:rPr lang="en-GB" sz="1200" baseline="0" dirty="0" err="1"/>
              <a:t>VBaP</a:t>
            </a:r>
            <a:r>
              <a:rPr lang="en-GB" sz="1200" baseline="0" dirty="0"/>
              <a:t> with additional 10nM all-trans retinoic acid and 10nM Vitamin D3 (VBaP+ATRA+VD3) for 6 hours. (A) The total GSH amount, (B) the reduced GSH amount, (C) the GSSG amount were tested by </a:t>
            </a:r>
            <a:r>
              <a:rPr lang="en-GB" sz="14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SH/GSSG-</a:t>
            </a:r>
            <a:r>
              <a:rPr lang="en-GB" sz="14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o</a:t>
            </a:r>
            <a:r>
              <a:rPr lang="en-GB" sz="14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™ Assay (</a:t>
            </a:r>
            <a:r>
              <a:rPr lang="en-GB" sz="14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mega</a:t>
            </a:r>
            <a:r>
              <a:rPr lang="en-GB" sz="14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ccording</a:t>
            </a:r>
            <a:r>
              <a:rPr lang="en-GB" sz="14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o the manufacture instruction. (D) The redox index was calculated with the ratio between GSH and GSSG.</a:t>
            </a:r>
            <a:r>
              <a:rPr lang="en-GB" sz="14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fferent letters indicates the significant</a:t>
            </a:r>
            <a:r>
              <a:rPr lang="en-GB" sz="14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fference from other treatment groups (p&lt;0.05).</a:t>
            </a:r>
            <a:endParaRPr lang="en-GB" sz="1400" dirty="0"/>
          </a:p>
          <a:p>
            <a:pPr marL="0" marR="0" lvl="0" indent="0" algn="l" defTabSz="128003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4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128003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34DB67-1BD7-400A-BB86-15D2B4973C11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719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9DFA55-BF3F-40FF-ADD9-A01313F585CA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083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/>
              <a:t>Figure 8. </a:t>
            </a:r>
            <a:r>
              <a:rPr lang="en-US" sz="1200" b="1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aP</a:t>
            </a:r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anges</a:t>
            </a:r>
            <a:r>
              <a:rPr lang="en-GB" sz="1200" b="1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rf2 target genes expression</a:t>
            </a:r>
            <a:endParaRPr lang="en-GB" sz="1200" b="1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B4,</a:t>
            </a:r>
            <a:r>
              <a:rPr lang="en-GB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KG1a and HL60 </a:t>
            </a:r>
            <a:r>
              <a:rPr lang="en-GB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 were treated with v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hicle control(CON),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6mM Valproate(VAL),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5 </a:t>
            </a:r>
            <a:r>
              <a:rPr lang="en-GB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EZ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5uM MPA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5mM), 0.1mM BEZ and 5uM MPA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1mM), the combination of Valproate 0.6mM and 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1mM (</a:t>
            </a:r>
            <a:r>
              <a:rPr lang="en-GB" sz="1200" b="0" i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aP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</a:t>
            </a:r>
            <a:r>
              <a:rPr lang="en-GB" sz="1200" baseline="0" dirty="0" err="1"/>
              <a:t>VBaP</a:t>
            </a:r>
            <a:r>
              <a:rPr lang="en-GB" sz="1200" baseline="0" dirty="0"/>
              <a:t> with additional 10nM all-trans retinoic acid and 10nM Vitamin D3 (VBaP+ATRA+VD3) for 4 hours. Total RNA were extracted with QIAGEN </a:t>
            </a:r>
            <a:r>
              <a:rPr lang="en-GB" sz="1200" baseline="0" dirty="0" err="1"/>
              <a:t>Rneasy</a:t>
            </a:r>
            <a:r>
              <a:rPr lang="en-GB" sz="1200" baseline="0" dirty="0"/>
              <a:t> Mini Kit and cDNA was synthesised with Invitrogen </a:t>
            </a:r>
            <a:r>
              <a:rPr lang="en-GB" sz="1200" baseline="0" dirty="0" err="1"/>
              <a:t>SuperScript</a:t>
            </a:r>
            <a:r>
              <a:rPr lang="en-GB" sz="1200" baseline="0" dirty="0"/>
              <a:t> II Reverse Transcriptase. </a:t>
            </a:r>
            <a:r>
              <a:rPr lang="en-GB" sz="1200" baseline="0" dirty="0" err="1"/>
              <a:t>qRT</a:t>
            </a:r>
            <a:r>
              <a:rPr lang="en-GB" sz="1200" baseline="0" dirty="0"/>
              <a:t>-PCR were performed to analysis NFE2L2, NQO1 and GSTA1 expression. Data were normalized by the amount of 18s mRNA and were showed as means ± SEM from n=3 experiments.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 letters indicates the significant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fference from other treatment groups (p&lt;0.05).</a:t>
            </a: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34DB67-1BD7-400A-BB86-15D2B4973C11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2946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987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6646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8616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0907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197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2028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716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69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2663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108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47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EBD64-948E-408E-B8CF-CC987FC1E299}" type="datetimeFigureOut">
              <a:rPr lang="en-GB" smtClean="0"/>
              <a:t>27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CFF49-51A7-4202-9F14-AD4B7B1E77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054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7.png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6.emf"/><Relationship Id="rId5" Type="http://schemas.openxmlformats.org/officeDocument/2006/relationships/image" Target="../media/image9.png"/><Relationship Id="rId10" Type="http://schemas.openxmlformats.org/officeDocument/2006/relationships/oleObject" Target="../embeddings/oleObject3.bin"/><Relationship Id="rId4" Type="http://schemas.openxmlformats.org/officeDocument/2006/relationships/image" Target="../media/image8.png"/><Relationship Id="rId9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oleObject" Target="../embeddings/oleObject9.bin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1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3.emf"/><Relationship Id="rId4" Type="http://schemas.openxmlformats.org/officeDocument/2006/relationships/image" Target="../media/image10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20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7.emf"/><Relationship Id="rId12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9.emf"/><Relationship Id="rId5" Type="http://schemas.openxmlformats.org/officeDocument/2006/relationships/image" Target="../media/image16.emf"/><Relationship Id="rId15" Type="http://schemas.openxmlformats.org/officeDocument/2006/relationships/image" Target="../media/image21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8.emf"/><Relationship Id="rId14" Type="http://schemas.openxmlformats.org/officeDocument/2006/relationships/oleObject" Target="../embeddings/oleObject15.bin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27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22.png"/><Relationship Id="rId21" Type="http://schemas.openxmlformats.org/officeDocument/2006/relationships/image" Target="../media/image31.png"/><Relationship Id="rId7" Type="http://schemas.openxmlformats.org/officeDocument/2006/relationships/image" Target="../media/image24.png"/><Relationship Id="rId12" Type="http://schemas.microsoft.com/office/2007/relationships/hdphoto" Target="../media/hdphoto5.wdp"/><Relationship Id="rId17" Type="http://schemas.openxmlformats.org/officeDocument/2006/relationships/image" Target="../media/image29.png"/><Relationship Id="rId25" Type="http://schemas.openxmlformats.org/officeDocument/2006/relationships/image" Target="../media/image33.png"/><Relationship Id="rId2" Type="http://schemas.openxmlformats.org/officeDocument/2006/relationships/notesSlide" Target="../notesSlides/notesSlide2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26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5" Type="http://schemas.openxmlformats.org/officeDocument/2006/relationships/image" Target="../media/image23.png"/><Relationship Id="rId15" Type="http://schemas.openxmlformats.org/officeDocument/2006/relationships/image" Target="../media/image28.png"/><Relationship Id="rId23" Type="http://schemas.openxmlformats.org/officeDocument/2006/relationships/image" Target="../media/image32.png"/><Relationship Id="rId28" Type="http://schemas.microsoft.com/office/2007/relationships/hdphoto" Target="../media/hdphoto13.wdp"/><Relationship Id="rId10" Type="http://schemas.microsoft.com/office/2007/relationships/hdphoto" Target="../media/hdphoto4.wdp"/><Relationship Id="rId19" Type="http://schemas.openxmlformats.org/officeDocument/2006/relationships/image" Target="../media/image30.png"/><Relationship Id="rId31" Type="http://schemas.openxmlformats.org/officeDocument/2006/relationships/image" Target="../media/image36.png"/><Relationship Id="rId4" Type="http://schemas.microsoft.com/office/2007/relationships/hdphoto" Target="../media/hdphoto1.wdp"/><Relationship Id="rId9" Type="http://schemas.openxmlformats.org/officeDocument/2006/relationships/image" Target="../media/image25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34.png"/><Relationship Id="rId30" Type="http://schemas.microsoft.com/office/2007/relationships/hdphoto" Target="../media/hdphoto14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41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38.emf"/><Relationship Id="rId12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40.emf"/><Relationship Id="rId5" Type="http://schemas.openxmlformats.org/officeDocument/2006/relationships/image" Target="../media/image37.emf"/><Relationship Id="rId15" Type="http://schemas.openxmlformats.org/officeDocument/2006/relationships/image" Target="../media/image42.em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6.bin"/><Relationship Id="rId9" Type="http://schemas.openxmlformats.org/officeDocument/2006/relationships/image" Target="../media/image39.emf"/><Relationship Id="rId14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83626" y="891025"/>
            <a:ext cx="2629350" cy="2672863"/>
            <a:chOff x="479302" y="769512"/>
            <a:chExt cx="2629350" cy="2672863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ABD37FE-2F03-4C2F-A552-8AE3832766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581" t="15886" r="17522" b="21157"/>
            <a:stretch/>
          </p:blipFill>
          <p:spPr>
            <a:xfrm>
              <a:off x="479302" y="769512"/>
              <a:ext cx="2629350" cy="2672863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E70059A-99EA-4279-8E42-3337208470F5}"/>
                </a:ext>
              </a:extLst>
            </p:cNvPr>
            <p:cNvSpPr txBox="1"/>
            <p:nvPr/>
          </p:nvSpPr>
          <p:spPr>
            <a:xfrm>
              <a:off x="1103063" y="1713026"/>
              <a:ext cx="1561964" cy="8024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923" dirty="0" err="1"/>
                <a:t>pPB</a:t>
              </a:r>
              <a:r>
                <a:rPr lang="en-GB" sz="923" dirty="0"/>
                <a:t>[Exp]-Hygro-EF1A&gt;hNFE2L2[NM_006164.5](ns):T2A:EGFP         </a:t>
              </a:r>
            </a:p>
            <a:p>
              <a:r>
                <a:rPr lang="en-GB" sz="923" dirty="0"/>
                <a:t>[VB200622-1240aqe</a:t>
              </a:r>
              <a:r>
                <a:rPr lang="en-GB" sz="923" dirty="0" smtClean="0"/>
                <a:t>]</a:t>
              </a:r>
              <a:endParaRPr lang="en-GB" sz="923" dirty="0"/>
            </a:p>
            <a:p>
              <a:r>
                <a:rPr lang="en-GB" sz="923" dirty="0"/>
                <a:t>10,082bp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26DBDF5-CB10-4461-A87D-BE0E1456F78B}"/>
              </a:ext>
            </a:extLst>
          </p:cNvPr>
          <p:cNvGrpSpPr/>
          <p:nvPr/>
        </p:nvGrpSpPr>
        <p:grpSpPr>
          <a:xfrm>
            <a:off x="589484" y="3838891"/>
            <a:ext cx="2620607" cy="2602441"/>
            <a:chOff x="290485" y="633638"/>
            <a:chExt cx="2838991" cy="2819311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E436C34A-9598-48E1-B95E-38A4C72C45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909" t="4414" r="6666" b="12663"/>
            <a:stretch/>
          </p:blipFill>
          <p:spPr>
            <a:xfrm>
              <a:off x="290485" y="633638"/>
              <a:ext cx="2838991" cy="2819311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8B15661-70DF-4373-8045-6C0C033A9D22}"/>
                </a:ext>
              </a:extLst>
            </p:cNvPr>
            <p:cNvSpPr txBox="1"/>
            <p:nvPr/>
          </p:nvSpPr>
          <p:spPr>
            <a:xfrm>
              <a:off x="1104376" y="1608625"/>
              <a:ext cx="1779397" cy="86933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923" dirty="0" err="1"/>
                <a:t>pRP</a:t>
              </a:r>
              <a:r>
                <a:rPr lang="en-GB" sz="923" dirty="0"/>
                <a:t>[Exp]-</a:t>
              </a:r>
              <a:r>
                <a:rPr lang="en-GB" sz="923" dirty="0" err="1"/>
                <a:t>mCherry</a:t>
              </a:r>
              <a:r>
                <a:rPr lang="en-GB" sz="923" dirty="0"/>
                <a:t>-CAG&gt;</a:t>
              </a:r>
              <a:r>
                <a:rPr lang="en-GB" sz="923" dirty="0" err="1"/>
                <a:t>hyPBase</a:t>
              </a:r>
              <a:endParaRPr lang="en-GB" sz="923" dirty="0"/>
            </a:p>
            <a:p>
              <a:endParaRPr lang="en-GB" sz="923" dirty="0"/>
            </a:p>
            <a:p>
              <a:r>
                <a:rPr lang="en-GB" sz="923" dirty="0"/>
                <a:t>[VB160216-10057</a:t>
              </a:r>
              <a:r>
                <a:rPr lang="en-GB" sz="923" dirty="0" smtClean="0"/>
                <a:t>]</a:t>
              </a:r>
              <a:endParaRPr lang="en-GB" sz="923" dirty="0"/>
            </a:p>
            <a:p>
              <a:r>
                <a:rPr lang="en-GB" sz="923" dirty="0"/>
                <a:t>7467bp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495985" y="846169"/>
            <a:ext cx="2644616" cy="2602441"/>
            <a:chOff x="3789040" y="160138"/>
            <a:chExt cx="2644616" cy="2602441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3AB5D89E-C856-463F-BAAD-05A21470658B}"/>
                </a:ext>
              </a:extLst>
            </p:cNvPr>
            <p:cNvGrpSpPr/>
            <p:nvPr/>
          </p:nvGrpSpPr>
          <p:grpSpPr>
            <a:xfrm>
              <a:off x="3789040" y="160138"/>
              <a:ext cx="2644616" cy="2602441"/>
              <a:chOff x="300010" y="6271533"/>
              <a:chExt cx="2865000" cy="2819311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6D2D4ADF-DB77-4D05-A745-F965FCA7D6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3588"/>
              <a:stretch/>
            </p:blipFill>
            <p:spPr>
              <a:xfrm>
                <a:off x="300010" y="6271533"/>
                <a:ext cx="2865000" cy="2819311"/>
              </a:xfrm>
              <a:prstGeom prst="rect">
                <a:avLst/>
              </a:prstGeom>
            </p:spPr>
          </p:pic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BDF04A93-CA89-4264-B5D8-B66BCD1A48F1}"/>
                  </a:ext>
                </a:extLst>
              </p:cNvPr>
              <p:cNvSpPr/>
              <p:nvPr/>
            </p:nvSpPr>
            <p:spPr>
              <a:xfrm>
                <a:off x="899887" y="7358743"/>
                <a:ext cx="1640114" cy="5950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 sz="1662"/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2BBE521-B790-4014-9423-54775E6E8F81}"/>
                </a:ext>
              </a:extLst>
            </p:cNvPr>
            <p:cNvSpPr txBox="1"/>
            <p:nvPr/>
          </p:nvSpPr>
          <p:spPr>
            <a:xfrm>
              <a:off x="4473385" y="1163716"/>
              <a:ext cx="1259871" cy="66043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923" dirty="0" err="1"/>
                <a:t>pPB</a:t>
              </a:r>
              <a:r>
                <a:rPr lang="en-GB" sz="923" dirty="0"/>
                <a:t>[Exp]-Hygro-EF1A&gt;EGFP  </a:t>
              </a:r>
            </a:p>
            <a:p>
              <a:r>
                <a:rPr lang="en-GB" sz="923" dirty="0"/>
                <a:t>[VB900088-2218fcw</a:t>
              </a:r>
              <a:r>
                <a:rPr lang="en-GB" sz="923" dirty="0" smtClean="0"/>
                <a:t>]</a:t>
              </a:r>
              <a:endParaRPr lang="en-GB" sz="923" dirty="0"/>
            </a:p>
            <a:p>
              <a:r>
                <a:rPr lang="en-GB" sz="923" dirty="0"/>
                <a:t>8204bp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CD40ECD7-0C6D-4D0F-8ACE-882FABF09536}"/>
              </a:ext>
            </a:extLst>
          </p:cNvPr>
          <p:cNvSpPr txBox="1"/>
          <p:nvPr/>
        </p:nvSpPr>
        <p:spPr>
          <a:xfrm>
            <a:off x="426371" y="812465"/>
            <a:ext cx="31451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62" b="1" dirty="0"/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1EBA9DD-4678-46D5-B1CF-4DD590BF89DB}"/>
              </a:ext>
            </a:extLst>
          </p:cNvPr>
          <p:cNvSpPr txBox="1"/>
          <p:nvPr/>
        </p:nvSpPr>
        <p:spPr>
          <a:xfrm>
            <a:off x="519723" y="6660232"/>
            <a:ext cx="58185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Figure S1. piggyback Nrf2 overexpression plasmids. </a:t>
            </a:r>
            <a:endParaRPr lang="en-GB" sz="1200" b="1" dirty="0"/>
          </a:p>
          <a:p>
            <a:r>
              <a:rPr lang="en-GB" sz="1200" dirty="0"/>
              <a:t>Plasmid maps of NRF2 overexpression plasmid (A), EGFP overexpression control plasmid (B) and </a:t>
            </a:r>
            <a:r>
              <a:rPr lang="en-GB" sz="1200" dirty="0" err="1"/>
              <a:t>PBase</a:t>
            </a:r>
            <a:r>
              <a:rPr lang="en-GB" sz="1200" dirty="0"/>
              <a:t> transposase plasmid (C) used for stable cell lines generation.</a:t>
            </a:r>
          </a:p>
          <a:p>
            <a:r>
              <a:rPr lang="en-GB" sz="1200" dirty="0"/>
              <a:t>The plasmids were cloned by </a:t>
            </a:r>
            <a:r>
              <a:rPr lang="en-GB" sz="1200" dirty="0" err="1"/>
              <a:t>VectorBuilder</a:t>
            </a:r>
            <a:r>
              <a:rPr lang="en-GB" sz="1200" dirty="0"/>
              <a:t> Inc., TX, USA. Plasmid names, codes and size are shown on the right hand side of the maps.</a:t>
            </a:r>
          </a:p>
        </p:txBody>
      </p:sp>
      <p:sp>
        <p:nvSpPr>
          <p:cNvPr id="17" name="Rectangle 16"/>
          <p:cNvSpPr/>
          <p:nvPr/>
        </p:nvSpPr>
        <p:spPr>
          <a:xfrm>
            <a:off x="108124" y="95997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40ECD7-0C6D-4D0F-8ACE-882FABF09536}"/>
              </a:ext>
            </a:extLst>
          </p:cNvPr>
          <p:cNvSpPr txBox="1"/>
          <p:nvPr/>
        </p:nvSpPr>
        <p:spPr>
          <a:xfrm>
            <a:off x="3271745" y="827584"/>
            <a:ext cx="31451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62" b="1" dirty="0" smtClean="0"/>
              <a:t>B</a:t>
            </a:r>
            <a:endParaRPr lang="en-GB" sz="1662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D40ECD7-0C6D-4D0F-8ACE-882FABF09536}"/>
              </a:ext>
            </a:extLst>
          </p:cNvPr>
          <p:cNvSpPr txBox="1"/>
          <p:nvPr/>
        </p:nvSpPr>
        <p:spPr>
          <a:xfrm>
            <a:off x="322047" y="3838891"/>
            <a:ext cx="29687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62" b="1" dirty="0" smtClean="0"/>
              <a:t>C</a:t>
            </a:r>
            <a:endParaRPr lang="en-GB" sz="1662" b="1" dirty="0"/>
          </a:p>
        </p:txBody>
      </p:sp>
    </p:spTree>
    <p:extLst>
      <p:ext uri="{BB962C8B-B14F-4D97-AF65-F5344CB8AC3E}">
        <p14:creationId xmlns:p14="http://schemas.microsoft.com/office/powerpoint/2010/main" val="117602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90576" y="1656553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7073" r="31463" b="12416"/>
          <a:stretch/>
        </p:blipFill>
        <p:spPr>
          <a:xfrm>
            <a:off x="1283971" y="1915671"/>
            <a:ext cx="935877" cy="51979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6621" r="33263" b="11032"/>
          <a:stretch/>
        </p:blipFill>
        <p:spPr>
          <a:xfrm>
            <a:off x="4575810" y="1907465"/>
            <a:ext cx="950935" cy="52800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/>
          <a:srcRect l="6800" r="32931" b="11230"/>
          <a:stretch/>
        </p:blipFill>
        <p:spPr>
          <a:xfrm>
            <a:off x="2960371" y="1908637"/>
            <a:ext cx="953356" cy="52683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366206" y="1764600"/>
            <a:ext cx="7968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NB4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MItoSOX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46493" y="1761994"/>
            <a:ext cx="8513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KG1a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MItoSOX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54250" y="1761995"/>
            <a:ext cx="9394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HL60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MItoSOX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5586840" y="1746407"/>
            <a:ext cx="990022" cy="646331"/>
            <a:chOff x="5739782" y="310363"/>
            <a:chExt cx="990022" cy="700192"/>
          </a:xfrm>
        </p:grpSpPr>
        <p:sp>
          <p:nvSpPr>
            <p:cNvPr id="22" name="TextBox 21"/>
            <p:cNvSpPr txBox="1"/>
            <p:nvPr/>
          </p:nvSpPr>
          <p:spPr>
            <a:xfrm>
              <a:off x="5815401" y="310363"/>
              <a:ext cx="914403" cy="700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ON             </a:t>
              </a:r>
            </a:p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VAL             </a:t>
              </a:r>
            </a:p>
            <a:p>
              <a:r>
                <a:rPr lang="en-GB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aP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 0.5mM            </a:t>
              </a:r>
              <a:r>
                <a:rPr lang="en-GB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aP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 0.1mM            </a:t>
              </a:r>
              <a:r>
                <a:rPr lang="en-GB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VBaP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5739782" y="525589"/>
              <a:ext cx="12415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5739782" y="615992"/>
              <a:ext cx="12415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5739782" y="706395"/>
              <a:ext cx="124157" cy="0"/>
            </a:xfrm>
            <a:prstGeom prst="line">
              <a:avLst/>
            </a:prstGeom>
            <a:ln w="28575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5739782" y="796798"/>
              <a:ext cx="124157" cy="0"/>
            </a:xfrm>
            <a:prstGeom prst="line">
              <a:avLst/>
            </a:prstGeom>
            <a:ln w="28575">
              <a:solidFill>
                <a:srgbClr val="5BD95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5739782" y="887201"/>
              <a:ext cx="124157" cy="0"/>
            </a:xfrm>
            <a:prstGeom prst="line">
              <a:avLst/>
            </a:prstGeom>
            <a:ln w="28575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 rot="16200000">
            <a:off x="983564" y="2083558"/>
            <a:ext cx="4516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ount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423724" y="2392738"/>
            <a:ext cx="681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Mitosox</a:t>
            </a:r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Red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675850" y="2083559"/>
            <a:ext cx="4516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ount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131250" y="2392738"/>
            <a:ext cx="681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Mitosox</a:t>
            </a:r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Red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4299556" y="2083559"/>
            <a:ext cx="4516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ounts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793056" y="2392738"/>
            <a:ext cx="6818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Mitosox</a:t>
            </a:r>
            <a:r>
              <a:rPr lang="en-GB" sz="7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Red</a:t>
            </a:r>
          </a:p>
        </p:txBody>
      </p:sp>
      <p:sp>
        <p:nvSpPr>
          <p:cNvPr id="29" name="Rectangle 28"/>
          <p:cNvSpPr/>
          <p:nvPr/>
        </p:nvSpPr>
        <p:spPr>
          <a:xfrm>
            <a:off x="108124" y="95997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90576" y="4693559"/>
            <a:ext cx="497494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upplementary Figure </a:t>
            </a:r>
            <a:r>
              <a:rPr lang="en-GB" sz="1200" b="1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2. </a:t>
            </a:r>
            <a:r>
              <a:rPr lang="en-US" sz="1200" b="1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VBaP</a:t>
            </a:r>
            <a:r>
              <a:rPr lang="en-US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</a:t>
            </a:r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does not change </a:t>
            </a:r>
            <a:r>
              <a:rPr lang="en-GB" sz="1200" b="1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itoSOX</a:t>
            </a:r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in AML cells. 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NB4, KG1a and HL60 cells were treated as shown for 24 hours, stained with </a:t>
            </a:r>
            <a:r>
              <a:rPr lang="en-US" sz="1200" dirty="0" err="1">
                <a:latin typeface="Times New Roman" panose="02020603050405020304" pitchFamily="18" charset="0"/>
                <a:ea typeface="DengXian"/>
              </a:rPr>
              <a:t>MitoSOX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 Red and </a:t>
            </a:r>
            <a:r>
              <a:rPr lang="en-US" sz="1200" dirty="0" err="1">
                <a:latin typeface="Times New Roman" panose="02020603050405020304" pitchFamily="18" charset="0"/>
                <a:ea typeface="DengXian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 by flow cytometry. Flow cytometry histograms show representative </a:t>
            </a:r>
            <a:r>
              <a:rPr lang="en-US" sz="1200" dirty="0" err="1">
                <a:latin typeface="Times New Roman" panose="02020603050405020304" pitchFamily="18" charset="0"/>
                <a:ea typeface="DengXian"/>
              </a:rPr>
              <a:t>MitoSOX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 data after 24 hours and bar charts mean data from n=4 experiments ± SEM. Abbreviations: vehicle control (CON), 0.6mM Valproic acid (VAL), 0.5 </a:t>
            </a:r>
            <a:r>
              <a:rPr lang="en-US" sz="1200" dirty="0" err="1">
                <a:latin typeface="Times New Roman" panose="02020603050405020304" pitchFamily="18" charset="0"/>
                <a:ea typeface="DengXian"/>
              </a:rPr>
              <a:t>mM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M MPA (BaP 0.5mM), 0.1mM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US" sz="1200" dirty="0">
                <a:latin typeface="Times New Roman" panose="02020603050405020304" pitchFamily="18" charset="0"/>
                <a:ea typeface="DengXian"/>
              </a:rPr>
              <a:t>M MPA (BaP 0.1mM), the combination of Valproic acid 0.6mM and BaP 0.1mM (VBaP).</a:t>
            </a:r>
            <a:endParaRPr lang="en-GB" sz="1200" dirty="0"/>
          </a:p>
        </p:txBody>
      </p:sp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3852DBD5-A890-4253-8707-56C0013E7E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8312887"/>
              </p:ext>
            </p:extLst>
          </p:nvPr>
        </p:nvGraphicFramePr>
        <p:xfrm>
          <a:off x="2587482" y="2678959"/>
          <a:ext cx="1478096" cy="18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Prism 8" r:id="rId6" imgW="3682028" imgH="4662554" progId="Prism8.Document">
                  <p:embed/>
                </p:oleObj>
              </mc:Choice>
              <mc:Fallback>
                <p:oleObj name="Prism 8" r:id="rId6" imgW="3682028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87482" y="2678959"/>
                        <a:ext cx="1478096" cy="187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FCDD83C2-4406-434C-887E-49F105A406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5761506"/>
              </p:ext>
            </p:extLst>
          </p:nvPr>
        </p:nvGraphicFramePr>
        <p:xfrm>
          <a:off x="901339" y="2678959"/>
          <a:ext cx="1478096" cy="18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" name="Prism 8" r:id="rId8" imgW="3682028" imgH="4662554" progId="Prism8.Document">
                  <p:embed/>
                </p:oleObj>
              </mc:Choice>
              <mc:Fallback>
                <p:oleObj name="Prism 8" r:id="rId8" imgW="3682028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01339" y="2678959"/>
                        <a:ext cx="1478096" cy="187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5FFCC434-BFF4-46E2-8976-91F73DEDA7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1734577"/>
              </p:ext>
            </p:extLst>
          </p:nvPr>
        </p:nvGraphicFramePr>
        <p:xfrm>
          <a:off x="4232901" y="2678959"/>
          <a:ext cx="1478096" cy="18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" name="Prism 8" r:id="rId10" imgW="3682028" imgH="4662554" progId="Prism8.Document">
                  <p:embed/>
                </p:oleObj>
              </mc:Choice>
              <mc:Fallback>
                <p:oleObj name="Prism 8" r:id="rId10" imgW="3682028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232901" y="2678959"/>
                        <a:ext cx="1478096" cy="187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22200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32"/>
          <p:cNvSpPr>
            <a:spLocks noChangeArrowheads="1"/>
          </p:cNvSpPr>
          <p:nvPr/>
        </p:nvSpPr>
        <p:spPr bwMode="auto">
          <a:xfrm>
            <a:off x="1798343" y="3024976"/>
            <a:ext cx="17240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65478" y="237469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26454" y="42975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584826" y="1449450"/>
            <a:ext cx="94969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educed </a:t>
            </a:r>
            <a:r>
              <a:rPr lang="en-GB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utathione</a:t>
            </a:r>
          </a:p>
          <a:p>
            <a:r>
              <a:rPr lang="en-GB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SH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589989" y="3003788"/>
            <a:ext cx="954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xidised glutathione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08124" y="95997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904650" y="4473786"/>
            <a:ext cx="525192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upplementary Figure </a:t>
            </a:r>
            <a:r>
              <a:rPr lang="en-GB" sz="1200" b="1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3. </a:t>
            </a:r>
            <a:r>
              <a:rPr lang="en-US" sz="1200" b="1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VBaP</a:t>
            </a:r>
            <a:r>
              <a:rPr lang="en-US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</a:t>
            </a:r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changed GSH/GSSH in AML cells. 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NB4, KG1a and HL60 cells were treated as shown for 4 hours for measurements of total reduced GSH (A) and oxidative GSSG (B) using the GSH/GSSG-</a:t>
            </a:r>
            <a:r>
              <a:rPr lang="en-GB" sz="1200" dirty="0" err="1">
                <a:latin typeface="Times New Roman" panose="02020603050405020304" pitchFamily="18" charset="0"/>
                <a:ea typeface="DengXian"/>
              </a:rPr>
              <a:t>Glo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™ Assay (see materials and methods). Data are mean ± SEM for n=4 experiments. Different letters indicates significant difference from other treatment groups (p&lt;0.05). Abbreviations: vehicle control (CON), 0.6mM Valproic acid (VAL), 0.5 </a:t>
            </a:r>
            <a:r>
              <a:rPr lang="en-GB" sz="1200" dirty="0" err="1">
                <a:latin typeface="Times New Roman" panose="02020603050405020304" pitchFamily="18" charset="0"/>
                <a:ea typeface="DengXian"/>
              </a:rPr>
              <a:t>mM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M MPA (BaP 0.5mM), 0.1mM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M MPA (BaP 0.1mM), the combination of Valproic acid 0.6mM and BaP 0.1mM (VBaP).</a:t>
            </a:r>
            <a:endParaRPr lang="en-GB" sz="1200" dirty="0"/>
          </a:p>
        </p:txBody>
      </p:sp>
      <p:sp>
        <p:nvSpPr>
          <p:cNvPr id="43" name="Rectangle 32">
            <a:extLst>
              <a:ext uri="{FF2B5EF4-FFF2-40B4-BE49-F238E27FC236}">
                <a16:creationId xmlns:a16="http://schemas.microsoft.com/office/drawing/2014/main" id="{CD4D5B40-83BE-46DC-AE01-4F1EADEDE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9994" y="1014224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32">
            <a:extLst>
              <a:ext uri="{FF2B5EF4-FFF2-40B4-BE49-F238E27FC236}">
                <a16:creationId xmlns:a16="http://schemas.microsoft.com/office/drawing/2014/main" id="{61214B3C-C637-405F-BA54-40CD99F481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4606" y="1026842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32">
            <a:extLst>
              <a:ext uri="{FF2B5EF4-FFF2-40B4-BE49-F238E27FC236}">
                <a16:creationId xmlns:a16="http://schemas.microsoft.com/office/drawing/2014/main" id="{E37FE31F-E66F-4B3B-B72D-EF88186908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5561" y="1286351"/>
            <a:ext cx="464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32">
            <a:extLst>
              <a:ext uri="{FF2B5EF4-FFF2-40B4-BE49-F238E27FC236}">
                <a16:creationId xmlns:a16="http://schemas.microsoft.com/office/drawing/2014/main" id="{1E1621E0-DD6C-4663-857D-79D5D60CF0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2843" y="1194018"/>
            <a:ext cx="89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32">
            <a:extLst>
              <a:ext uri="{FF2B5EF4-FFF2-40B4-BE49-F238E27FC236}">
                <a16:creationId xmlns:a16="http://schemas.microsoft.com/office/drawing/2014/main" id="{F3996545-4DAD-4C8D-8956-FE24A31533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4638" y="1101685"/>
            <a:ext cx="17240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32">
            <a:extLst>
              <a:ext uri="{FF2B5EF4-FFF2-40B4-BE49-F238E27FC236}">
                <a16:creationId xmlns:a16="http://schemas.microsoft.com/office/drawing/2014/main" id="{DF8253B5-8E45-4B56-A8BB-5EBF48B85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1783" y="1119175"/>
            <a:ext cx="17240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32">
            <a:extLst>
              <a:ext uri="{FF2B5EF4-FFF2-40B4-BE49-F238E27FC236}">
                <a16:creationId xmlns:a16="http://schemas.microsoft.com/office/drawing/2014/main" id="{F4683C9D-4B86-40A2-909C-81F8249E3F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5910" y="1371791"/>
            <a:ext cx="17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32">
            <a:extLst>
              <a:ext uri="{FF2B5EF4-FFF2-40B4-BE49-F238E27FC236}">
                <a16:creationId xmlns:a16="http://schemas.microsoft.com/office/drawing/2014/main" id="{2BCA6965-B266-45D1-99D5-B344EE1857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1829" y="1371791"/>
            <a:ext cx="17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32">
            <a:extLst>
              <a:ext uri="{FF2B5EF4-FFF2-40B4-BE49-F238E27FC236}">
                <a16:creationId xmlns:a16="http://schemas.microsoft.com/office/drawing/2014/main" id="{1BA832D7-645C-46F7-9FE1-8BF77238D0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3489" y="1371790"/>
            <a:ext cx="89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32">
            <a:extLst>
              <a:ext uri="{FF2B5EF4-FFF2-40B4-BE49-F238E27FC236}">
                <a16:creationId xmlns:a16="http://schemas.microsoft.com/office/drawing/2014/main" id="{378CC3B5-2F96-4E03-9878-63C219C5E8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6584" y="1464123"/>
            <a:ext cx="17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32">
            <a:extLst>
              <a:ext uri="{FF2B5EF4-FFF2-40B4-BE49-F238E27FC236}">
                <a16:creationId xmlns:a16="http://schemas.microsoft.com/office/drawing/2014/main" id="{6C444B7D-54C6-415E-8EA8-357064DB2F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5153" y="1357117"/>
            <a:ext cx="17240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28">
            <a:extLst>
              <a:ext uri="{FF2B5EF4-FFF2-40B4-BE49-F238E27FC236}">
                <a16:creationId xmlns:a16="http://schemas.microsoft.com/office/drawing/2014/main" id="{095226B8-539B-4ACB-BC63-1592FD8D6F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4179" y="1438041"/>
            <a:ext cx="11581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32">
            <a:extLst>
              <a:ext uri="{FF2B5EF4-FFF2-40B4-BE49-F238E27FC236}">
                <a16:creationId xmlns:a16="http://schemas.microsoft.com/office/drawing/2014/main" id="{0E976D40-E385-42C9-B909-1D4082EBE7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8206" y="2684982"/>
            <a:ext cx="17240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32">
            <a:extLst>
              <a:ext uri="{FF2B5EF4-FFF2-40B4-BE49-F238E27FC236}">
                <a16:creationId xmlns:a16="http://schemas.microsoft.com/office/drawing/2014/main" id="{C107AC4E-075C-4331-A349-BCE7EA4F28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6529" y="2957621"/>
            <a:ext cx="2372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32">
            <a:extLst>
              <a:ext uri="{FF2B5EF4-FFF2-40B4-BE49-F238E27FC236}">
                <a16:creationId xmlns:a16="http://schemas.microsoft.com/office/drawing/2014/main" id="{DCD9D83A-9354-43DA-8BE2-AC690FB21F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6574" y="3108515"/>
            <a:ext cx="2372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32">
            <a:extLst>
              <a:ext uri="{FF2B5EF4-FFF2-40B4-BE49-F238E27FC236}">
                <a16:creationId xmlns:a16="http://schemas.microsoft.com/office/drawing/2014/main" id="{27815265-745B-4380-9EDA-170AC5BEA9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7621" y="3074507"/>
            <a:ext cx="2372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32">
            <a:extLst>
              <a:ext uri="{FF2B5EF4-FFF2-40B4-BE49-F238E27FC236}">
                <a16:creationId xmlns:a16="http://schemas.microsoft.com/office/drawing/2014/main" id="{C9E66695-1388-4712-9DC3-A80939491A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7577" y="3071142"/>
            <a:ext cx="2372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lr>
                <a:srgbClr val="4C6B66"/>
              </a:buClr>
              <a:buSzPct val="80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spcBef>
                <a:spcPct val="20000"/>
              </a:spcBef>
              <a:buClr>
                <a:srgbClr val="4C6B66"/>
              </a:buClr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spcBef>
                <a:spcPct val="20000"/>
              </a:spcBef>
              <a:buClr>
                <a:srgbClr val="4C6B66"/>
              </a:buClr>
              <a:buSzPct val="65000"/>
              <a:buFont typeface="Wingdings" pitchFamily="2" charset="2"/>
              <a:buChar char="o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spcBef>
                <a:spcPct val="20000"/>
              </a:spcBef>
              <a:buClr>
                <a:srgbClr val="4C6B66"/>
              </a:buClr>
              <a:buSzPct val="80000"/>
              <a:buChar char="–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spcBef>
                <a:spcPct val="20000"/>
              </a:spcBef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4C6B66"/>
              </a:buClr>
              <a:buSzPct val="90000"/>
              <a:buChar char="»"/>
              <a:defRPr sz="2800">
                <a:solidFill>
                  <a:schemeClr val="bg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zh-CN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zh-CN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979D1A4C-BBB3-45BA-A44D-D337A080CF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946547"/>
              </p:ext>
            </p:extLst>
          </p:nvPr>
        </p:nvGraphicFramePr>
        <p:xfrm>
          <a:off x="4079570" y="560556"/>
          <a:ext cx="1451546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" name="Prism 8" r:id="rId3" imgW="3686349" imgH="4662554" progId="Prism8.Document">
                  <p:embed/>
                </p:oleObj>
              </mc:Choice>
              <mc:Fallback>
                <p:oleObj name="Prism 8" r:id="rId3" imgW="3686349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79570" y="560556"/>
                        <a:ext cx="1451546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8BE33C38-C7E1-4DDD-8F5E-DB7A15847E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1528010"/>
              </p:ext>
            </p:extLst>
          </p:nvPr>
        </p:nvGraphicFramePr>
        <p:xfrm>
          <a:off x="2575957" y="560556"/>
          <a:ext cx="1451546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" name="Prism 8" r:id="rId5" imgW="3686349" imgH="4662554" progId="Prism8.Document">
                  <p:embed/>
                </p:oleObj>
              </mc:Choice>
              <mc:Fallback>
                <p:oleObj name="Prism 8" r:id="rId5" imgW="3686349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75957" y="560556"/>
                        <a:ext cx="1451546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2B581EBB-6BB9-40AE-BC63-C0C7DBE484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1511414"/>
              </p:ext>
            </p:extLst>
          </p:nvPr>
        </p:nvGraphicFramePr>
        <p:xfrm>
          <a:off x="1046431" y="560556"/>
          <a:ext cx="1451546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6" name="Prism 8" r:id="rId7" imgW="3686349" imgH="4662554" progId="Prism8.Document">
                  <p:embed/>
                </p:oleObj>
              </mc:Choice>
              <mc:Fallback>
                <p:oleObj name="Prism 8" r:id="rId7" imgW="3686349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46431" y="560556"/>
                        <a:ext cx="1451546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987313B4-7B17-400D-B05E-A086FAF8BC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8967387"/>
              </p:ext>
            </p:extLst>
          </p:nvPr>
        </p:nvGraphicFramePr>
        <p:xfrm>
          <a:off x="4033074" y="2468443"/>
          <a:ext cx="1502182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7" name="Prism 8" r:id="rId9" imgW="3814557" imgH="4662554" progId="Prism8.Document">
                  <p:embed/>
                </p:oleObj>
              </mc:Choice>
              <mc:Fallback>
                <p:oleObj name="Prism 8" r:id="rId9" imgW="3814557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33074" y="2468443"/>
                        <a:ext cx="1502182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F58DC260-AEDB-4516-9084-73FF028252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251264"/>
              </p:ext>
            </p:extLst>
          </p:nvPr>
        </p:nvGraphicFramePr>
        <p:xfrm>
          <a:off x="970083" y="2468443"/>
          <a:ext cx="1502182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8" name="Prism 8" r:id="rId11" imgW="3814557" imgH="4662554" progId="Prism8.Document">
                  <p:embed/>
                </p:oleObj>
              </mc:Choice>
              <mc:Fallback>
                <p:oleObj name="Prism 8" r:id="rId11" imgW="3814557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70083" y="2468443"/>
                        <a:ext cx="1502182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7EFEE2E0-730B-474F-839C-8DE38F9D41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4857573"/>
              </p:ext>
            </p:extLst>
          </p:nvPr>
        </p:nvGraphicFramePr>
        <p:xfrm>
          <a:off x="2542469" y="2468443"/>
          <a:ext cx="1502182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9" name="Prism 8" r:id="rId13" imgW="3814557" imgH="4662554" progId="Prism8.Document">
                  <p:embed/>
                </p:oleObj>
              </mc:Choice>
              <mc:Fallback>
                <p:oleObj name="Prism 8" r:id="rId13" imgW="3814557" imgH="46625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542469" y="2468443"/>
                        <a:ext cx="1502182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13154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Rectangle 112"/>
          <p:cNvSpPr/>
          <p:nvPr/>
        </p:nvSpPr>
        <p:spPr>
          <a:xfrm>
            <a:off x="363576" y="95997"/>
            <a:ext cx="1800493" cy="2628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8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8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DCB63B13-E415-4B3B-B177-5B1DB66C65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7157416"/>
              </p:ext>
            </p:extLst>
          </p:nvPr>
        </p:nvGraphicFramePr>
        <p:xfrm>
          <a:off x="2920938" y="2250350"/>
          <a:ext cx="1269023" cy="172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39" name="Prism 9" r:id="rId4" imgW="3434974" imgH="4676292" progId="Prism9.Document">
                  <p:embed/>
                </p:oleObj>
              </mc:Choice>
              <mc:Fallback>
                <p:oleObj name="Prism 9" r:id="rId4" imgW="3434974" imgH="4676292" progId="Prism9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DCB63B13-E415-4B3B-B177-5B1DB66C65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20938" y="2250350"/>
                        <a:ext cx="1269023" cy="172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4E07E5A5-C6B6-42F7-AB01-1E65AC5A8A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9028533"/>
              </p:ext>
            </p:extLst>
          </p:nvPr>
        </p:nvGraphicFramePr>
        <p:xfrm>
          <a:off x="4224012" y="2232766"/>
          <a:ext cx="1269023" cy="172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0" name="Prism 9" r:id="rId6" imgW="3434974" imgH="4676292" progId="Prism9.Document">
                  <p:embed/>
                </p:oleObj>
              </mc:Choice>
              <mc:Fallback>
                <p:oleObj name="Prism 9" r:id="rId6" imgW="3434974" imgH="4676292" progId="Prism9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4E07E5A5-C6B6-42F7-AB01-1E65AC5A8A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224012" y="2232766"/>
                        <a:ext cx="1269023" cy="172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61D52190-70C9-4D16-8F1D-C6E0687979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9742162"/>
              </p:ext>
            </p:extLst>
          </p:nvPr>
        </p:nvGraphicFramePr>
        <p:xfrm>
          <a:off x="1499514" y="2244489"/>
          <a:ext cx="1415562" cy="172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1" name="Prism 9" r:id="rId8" imgW="3837246" imgH="4676292" progId="Prism9.Document">
                  <p:embed/>
                </p:oleObj>
              </mc:Choice>
              <mc:Fallback>
                <p:oleObj name="Prism 9" r:id="rId8" imgW="3837246" imgH="4676292" progId="Prism9.Document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61D52190-70C9-4D16-8F1D-C6E0687979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499514" y="2244489"/>
                        <a:ext cx="1415562" cy="172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EA5EF23B-25BB-4770-B8EA-769C2E6679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6665124"/>
              </p:ext>
            </p:extLst>
          </p:nvPr>
        </p:nvGraphicFramePr>
        <p:xfrm>
          <a:off x="1547431" y="915384"/>
          <a:ext cx="1390650" cy="133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2" name="Prism 9" r:id="rId10" imgW="3764138" imgH="3617034" progId="Prism9.Document">
                  <p:embed/>
                </p:oleObj>
              </mc:Choice>
              <mc:Fallback>
                <p:oleObj name="Prism 9" r:id="rId10" imgW="3764138" imgH="3617034" progId="Prism9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EA5EF23B-25BB-4770-B8EA-769C2E6679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47431" y="915384"/>
                        <a:ext cx="1390650" cy="133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0FC3E218-5751-4D7B-979E-649012934D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5206768"/>
              </p:ext>
            </p:extLst>
          </p:nvPr>
        </p:nvGraphicFramePr>
        <p:xfrm>
          <a:off x="2957131" y="925404"/>
          <a:ext cx="1269023" cy="133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3" name="Prism 9" r:id="rId12" imgW="3433174" imgH="3617034" progId="Prism9.Document">
                  <p:embed/>
                </p:oleObj>
              </mc:Choice>
              <mc:Fallback>
                <p:oleObj name="Prism 9" r:id="rId12" imgW="3433174" imgH="3617034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0FC3E218-5751-4D7B-979E-649012934D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957131" y="925404"/>
                        <a:ext cx="1269023" cy="133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8AC1A1F8-5DF7-428D-807B-58D0B3A5EA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2344386"/>
              </p:ext>
            </p:extLst>
          </p:nvPr>
        </p:nvGraphicFramePr>
        <p:xfrm>
          <a:off x="4254345" y="924176"/>
          <a:ext cx="1267557" cy="133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4" name="Prism 9" r:id="rId14" imgW="3433174" imgH="3617034" progId="Prism9.Document">
                  <p:embed/>
                </p:oleObj>
              </mc:Choice>
              <mc:Fallback>
                <p:oleObj name="Prism 9" r:id="rId14" imgW="3433174" imgH="3617034" progId="Prism9.Document">
                  <p:embed/>
                  <p:pic>
                    <p:nvPicPr>
                      <p:cNvPr id="6" name="对象 5">
                        <a:extLst>
                          <a:ext uri="{FF2B5EF4-FFF2-40B4-BE49-F238E27FC236}">
                            <a16:creationId xmlns:a16="http://schemas.microsoft.com/office/drawing/2014/main" id="{8AC1A1F8-5DF7-428D-807B-58D0B3A5EA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254345" y="924176"/>
                        <a:ext cx="1267557" cy="133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5" name="TextBox 194"/>
          <p:cNvSpPr txBox="1"/>
          <p:nvPr/>
        </p:nvSpPr>
        <p:spPr>
          <a:xfrm>
            <a:off x="1282339" y="862349"/>
            <a:ext cx="173033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1246678" y="2255638"/>
            <a:ext cx="173033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15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2276050" y="1326562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2469150" y="1240046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2663942" y="1254725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3555450" y="1413338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3750829" y="1326821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4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6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936029" y="1345788"/>
            <a:ext cx="282450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en-GB" sz="6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351374" y="1216013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4857631" y="1403465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5058071" y="1249659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5247929" y="1273691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9" name="TextBox 228"/>
          <p:cNvSpPr txBox="1"/>
          <p:nvPr/>
        </p:nvSpPr>
        <p:spPr>
          <a:xfrm>
            <a:off x="3532818" y="2572011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0" name="TextBox 229"/>
          <p:cNvSpPr txBox="1"/>
          <p:nvPr/>
        </p:nvSpPr>
        <p:spPr>
          <a:xfrm>
            <a:off x="3723763" y="2644904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1" name="TextBox 230"/>
          <p:cNvSpPr txBox="1"/>
          <p:nvPr/>
        </p:nvSpPr>
        <p:spPr>
          <a:xfrm>
            <a:off x="3921087" y="2486290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4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64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3323935" y="2651188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4" name="TextBox 233"/>
          <p:cNvSpPr txBox="1"/>
          <p:nvPr/>
        </p:nvSpPr>
        <p:spPr>
          <a:xfrm>
            <a:off x="5021038" y="2670131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5210597" y="2607456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4827336" y="2418481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2243481" y="2439281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0" name="TextBox 239"/>
          <p:cNvSpPr txBox="1"/>
          <p:nvPr/>
        </p:nvSpPr>
        <p:spPr>
          <a:xfrm>
            <a:off x="2441339" y="2563194"/>
            <a:ext cx="235963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1" name="TextBox 240"/>
          <p:cNvSpPr txBox="1"/>
          <p:nvPr/>
        </p:nvSpPr>
        <p:spPr>
          <a:xfrm>
            <a:off x="2645453" y="2413934"/>
            <a:ext cx="231154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2" name="TextBox 241"/>
          <p:cNvSpPr txBox="1"/>
          <p:nvPr/>
        </p:nvSpPr>
        <p:spPr>
          <a:xfrm>
            <a:off x="2023527" y="2485816"/>
            <a:ext cx="282450" cy="191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46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246" name="TextBox 245"/>
          <p:cNvSpPr txBox="1"/>
          <p:nvPr/>
        </p:nvSpPr>
        <p:spPr>
          <a:xfrm>
            <a:off x="2177596" y="779189"/>
            <a:ext cx="46839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8" b="1" dirty="0">
                <a:latin typeface="Arial" panose="020B0604020202020204" pitchFamily="34" charset="0"/>
                <a:cs typeface="Arial" panose="020B0604020202020204" pitchFamily="34" charset="0"/>
              </a:rPr>
              <a:t>NB4</a:t>
            </a:r>
          </a:p>
        </p:txBody>
      </p:sp>
      <p:sp>
        <p:nvSpPr>
          <p:cNvPr id="247" name="TextBox 246"/>
          <p:cNvSpPr txBox="1"/>
          <p:nvPr/>
        </p:nvSpPr>
        <p:spPr>
          <a:xfrm>
            <a:off x="3410644" y="779488"/>
            <a:ext cx="554960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8" b="1" dirty="0">
                <a:latin typeface="Arial" panose="020B0604020202020204" pitchFamily="34" charset="0"/>
                <a:cs typeface="Arial" panose="020B0604020202020204" pitchFamily="34" charset="0"/>
              </a:rPr>
              <a:t>KG1a</a:t>
            </a:r>
          </a:p>
        </p:txBody>
      </p:sp>
      <p:sp>
        <p:nvSpPr>
          <p:cNvPr id="248" name="TextBox 247"/>
          <p:cNvSpPr txBox="1"/>
          <p:nvPr/>
        </p:nvSpPr>
        <p:spPr>
          <a:xfrm>
            <a:off x="4751365" y="771491"/>
            <a:ext cx="53091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8" b="1" dirty="0">
                <a:latin typeface="Arial" panose="020B0604020202020204" pitchFamily="34" charset="0"/>
                <a:cs typeface="Arial" panose="020B0604020202020204" pitchFamily="34" charset="0"/>
              </a:rPr>
              <a:t>HL60</a:t>
            </a:r>
          </a:p>
        </p:txBody>
      </p:sp>
      <p:sp>
        <p:nvSpPr>
          <p:cNvPr id="3" name="Rectangle 2"/>
          <p:cNvSpPr/>
          <p:nvPr/>
        </p:nvSpPr>
        <p:spPr>
          <a:xfrm>
            <a:off x="208432" y="4305993"/>
            <a:ext cx="6517037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b="1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upplementary Figure S4. </a:t>
            </a:r>
            <a:r>
              <a:rPr lang="en-GB" sz="11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VBaP modulates lipid peroxidation and Prostaglandin synthesis.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(A) NB4, KG1a and HL60 cells were loaded with the naturally fluorescent lipid </a:t>
            </a:r>
            <a:r>
              <a:rPr lang="en-GB" sz="1100" i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cis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-</a:t>
            </a:r>
            <a:r>
              <a:rPr lang="en-GB" sz="11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arinaric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acid and treated as shown for 6 hrs to enable measurement of treatment associated lipid peroxidation (loss of signal). Data are presented as % fluorescence units (FLU) compared to solvent control for N = 3 </a:t>
            </a:r>
            <a:r>
              <a:rPr lang="en-US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± SEM. 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(B &amp; C) Levels of </a:t>
            </a:r>
            <a:r>
              <a:rPr lang="en-GB" sz="1100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15deoxyΔ-Prostaglandin 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J</a:t>
            </a:r>
            <a:r>
              <a:rPr lang="en-GB" sz="1100" kern="100" baseline="-25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2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(15d-PGJ</a:t>
            </a:r>
            <a:r>
              <a:rPr lang="en-GB" sz="1100" kern="100" baseline="-25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2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) </a:t>
            </a:r>
            <a:r>
              <a:rPr lang="en-GB" sz="1100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(B) 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were determined by ELISA in NB4, KG1a and HL60 cells by ELISA following 6 hours treatment. Prostaglandin levels are shown as mean ±SEM from a minimum of N=3 experiments. Different letters indicate significant difference from other treatment groups (p&lt;0.05). Abbreviations: vehicle control (CON), 0.6mM Valproic acid (VAL), 0.5 </a:t>
            </a:r>
            <a:r>
              <a:rPr lang="en-GB" sz="11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M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BEZ and 5</a:t>
            </a:r>
            <a:r>
              <a:rPr lang="el-GR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μ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 MPA (BaP 0.5mM), 0.1mM BEZ and 5</a:t>
            </a:r>
            <a:r>
              <a:rPr lang="el-GR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μ</a:t>
            </a:r>
            <a:r>
              <a:rPr lang="en-GB" sz="11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 MPA (BaP 0.1mM), the combination of Valproic acid 0.6mM and BaP 0.1mM (VBaP).</a:t>
            </a:r>
            <a:endParaRPr lang="en-GB" sz="1000" kern="100" dirty="0">
              <a:effectLst/>
              <a:latin typeface="DengXian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08432" y="6197517"/>
            <a:ext cx="6517037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Lipid Peroxidation assay</a:t>
            </a:r>
            <a:endParaRPr lang="en-GB" sz="1050" kern="100" dirty="0">
              <a:latin typeface="DengXian"/>
              <a:ea typeface="DengXian"/>
              <a:cs typeface="Times New Roman" panose="02020603050405020304" pitchFamily="18" charset="0"/>
            </a:endParaRPr>
          </a:p>
          <a:p>
            <a:pPr algn="just"/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2x10</a:t>
            </a:r>
            <a:r>
              <a:rPr lang="en-US" sz="1200" kern="100" baseline="30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6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cells at 2.5 x 10</a:t>
            </a:r>
            <a:r>
              <a:rPr lang="en-US" sz="1200" kern="100" baseline="30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5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/ml were treated at 37ºC for 6 hours. For the last 30min, 10nM cis-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arinaric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acid (Cambridge Biosciences, UK) was added to the cultures to label cell membranes. Cells were harvested and lipids extracted in the dark for 1 hour with isopropanol containing 0.05% butylated 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hydroxytoluene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. Fluorescence was measured at 320nm excitation and 415nm emission and background (fluorescence of unlabeled control cells) subtracted from all values. Data is presented as % fluorescence units (FLU) compared to solvent control cells.</a:t>
            </a:r>
            <a:endParaRPr lang="en-GB" sz="1050" kern="100" dirty="0">
              <a:latin typeface="DengXian"/>
              <a:ea typeface="DengXian"/>
              <a:cs typeface="Times New Roman" panose="02020603050405020304" pitchFamily="18" charset="0"/>
            </a:endParaRPr>
          </a:p>
          <a:p>
            <a:pPr algn="just"/>
            <a:r>
              <a:rPr lang="en-US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rostaglandin ELISAs</a:t>
            </a:r>
            <a:endParaRPr lang="en-GB" sz="1050" kern="100" dirty="0">
              <a:latin typeface="DengXian"/>
              <a:ea typeface="DengXian"/>
              <a:cs typeface="Times New Roman" panose="02020603050405020304" pitchFamily="18" charset="0"/>
            </a:endParaRPr>
          </a:p>
          <a:p>
            <a:pPr algn="just"/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rostaglandin D</a:t>
            </a:r>
            <a:r>
              <a:rPr lang="en-US" sz="1200" kern="100" baseline="-25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-MOX EIA kit (Cayman Chemicals, USA) and 15Δ-</a:t>
            </a:r>
            <a:r>
              <a:rPr lang="en-US" sz="1200" kern="100" baseline="30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12,14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-Prostaglandin J</a:t>
            </a:r>
            <a:r>
              <a:rPr lang="en-US" sz="1200" kern="100" baseline="-25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Enzyme Immunoassay Kit (Enzo Inc., UK) were used to determine prostaglandin levels. After treating 5×10</a:t>
            </a:r>
            <a:r>
              <a:rPr lang="en-US" sz="1200" kern="100" baseline="300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6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cells in 5ml media for </a:t>
            </a:r>
            <a:r>
              <a:rPr lang="en-US" sz="1200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6 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hours, cells were harvested with 1ml culture media and 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homogenised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using a 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recellys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24 ceramic bead 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homogenisation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system (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Bertin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instruments, UK). Prostaglandins were extracted using C18 reverse phase extraction columns (</a:t>
            </a:r>
            <a:r>
              <a:rPr lang="en-US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Chromabond</a:t>
            </a:r>
            <a:r>
              <a:rPr lang="en-US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, Fisher, UK) and levels determined by ELISA according to manufacturer’s instructions.</a:t>
            </a:r>
            <a:endParaRPr lang="en-GB" sz="1050" kern="100" dirty="0">
              <a:effectLst/>
              <a:latin typeface="DengXian"/>
              <a:ea typeface="DengXi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57425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849" y="668476"/>
            <a:ext cx="1393371" cy="139337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849" y="2108636"/>
            <a:ext cx="1393371" cy="139337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849" y="3520440"/>
            <a:ext cx="1393371" cy="139337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849" y="4942167"/>
            <a:ext cx="1393371" cy="1393371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60000"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1509" y="4942167"/>
            <a:ext cx="1393371" cy="139337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885" y="4942167"/>
            <a:ext cx="1393371" cy="1393371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849" y="6346981"/>
            <a:ext cx="1393371" cy="139337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875433" y="464017"/>
            <a:ext cx="522900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86" dirty="0"/>
              <a:t>HL60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885" y="667464"/>
            <a:ext cx="1393371" cy="1393371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60000"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1509" y="667464"/>
            <a:ext cx="1393371" cy="1393371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885" y="2101468"/>
            <a:ext cx="1393371" cy="1393371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60000"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1509" y="2101468"/>
            <a:ext cx="1393371" cy="1393371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60000"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9172" y="3520440"/>
            <a:ext cx="1393371" cy="1393371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885" y="3520440"/>
            <a:ext cx="1393371" cy="1393371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885" y="6346981"/>
            <a:ext cx="1393371" cy="1393371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60000"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3623" y="6346981"/>
            <a:ext cx="1393371" cy="1393371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1015449" y="1352864"/>
            <a:ext cx="491225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/>
              <a:t>CO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063109" y="2716004"/>
            <a:ext cx="443584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/>
              <a:t>VAL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32772" y="4075895"/>
            <a:ext cx="973344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err="1"/>
              <a:t>BaP</a:t>
            </a:r>
            <a:r>
              <a:rPr lang="en-GB" sz="1286" b="1" dirty="0"/>
              <a:t> 0.5mM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32772" y="5527618"/>
            <a:ext cx="973344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err="1"/>
              <a:t>BaP</a:t>
            </a:r>
            <a:r>
              <a:rPr lang="en-GB" sz="1286" b="1" dirty="0"/>
              <a:t> 0.1mM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961460" y="6916449"/>
            <a:ext cx="545342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err="1"/>
              <a:t>VBaP</a:t>
            </a:r>
            <a:endParaRPr lang="en-GB" sz="1286" b="1" dirty="0"/>
          </a:p>
        </p:txBody>
      </p:sp>
      <p:sp>
        <p:nvSpPr>
          <p:cNvPr id="2" name="Rectangle 1"/>
          <p:cNvSpPr/>
          <p:nvPr/>
        </p:nvSpPr>
        <p:spPr>
          <a:xfrm>
            <a:off x="532772" y="7889781"/>
            <a:ext cx="584855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ea typeface="DengXian"/>
              </a:rPr>
              <a:t>Supplementary Figure S5. VAL reduces Nrf2 expression</a:t>
            </a:r>
            <a:r>
              <a:rPr lang="en-GB" sz="1200" dirty="0" smtClean="0">
                <a:latin typeface="Times New Roman" panose="02020603050405020304" pitchFamily="18" charset="0"/>
                <a:ea typeface="DengXian"/>
              </a:rPr>
              <a:t>. HL60 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cells were treated as shown for 4 hour and </a:t>
            </a:r>
            <a:r>
              <a:rPr lang="en-GB" sz="1200" dirty="0" err="1">
                <a:latin typeface="Times New Roman" panose="02020603050405020304" pitchFamily="18" charset="0"/>
                <a:ea typeface="DengXian"/>
              </a:rPr>
              <a:t>cytospins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 prepared before fixing with paraformaldehyde and immunostaining staining for Nrf2 (red) and staining for nuclei with DAPI (blue). Scale bar indicates 20</a:t>
            </a:r>
            <a:r>
              <a:rPr lang="en-GB" sz="1200" dirty="0">
                <a:latin typeface="Symbol" panose="05050102010706020507" pitchFamily="18" charset="2"/>
                <a:ea typeface="DengXian"/>
                <a:cs typeface="Times New Roman" panose="02020603050405020304" pitchFamily="18" charset="0"/>
              </a:rPr>
              <a:t>m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m. Abbreviations: vehicle control (CON), 0.6mM Valproic acid (VAL), 0.5 </a:t>
            </a:r>
            <a:r>
              <a:rPr lang="en-GB" sz="1200" dirty="0" err="1">
                <a:latin typeface="Times New Roman" panose="02020603050405020304" pitchFamily="18" charset="0"/>
                <a:ea typeface="DengXian"/>
              </a:rPr>
              <a:t>mM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M MPA (BaP 0.5mM), 0.1mM BEZ and 5</a:t>
            </a:r>
            <a:r>
              <a:rPr lang="el-GR" sz="1200" dirty="0">
                <a:latin typeface="Times New Roman" panose="02020603050405020304" pitchFamily="18" charset="0"/>
                <a:ea typeface="DengXian"/>
              </a:rPr>
              <a:t>μ</a:t>
            </a:r>
            <a:r>
              <a:rPr lang="en-GB" sz="1200" dirty="0">
                <a:latin typeface="Times New Roman" panose="02020603050405020304" pitchFamily="18" charset="0"/>
                <a:ea typeface="DengXian"/>
              </a:rPr>
              <a:t>M MPA (BaP 0.1mM), the combination of Valproic acid 0.6mM and BaP 0.1mM (VBaP).</a:t>
            </a:r>
            <a:endParaRPr lang="en-GB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1918610" y="398523"/>
            <a:ext cx="515847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smtClean="0"/>
              <a:t>DAPI</a:t>
            </a:r>
            <a:endParaRPr lang="en-GB" sz="1286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374667" y="395111"/>
            <a:ext cx="489238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smtClean="0"/>
              <a:t>Nrf2</a:t>
            </a:r>
            <a:endParaRPr lang="en-GB" sz="1286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4718752" y="391699"/>
            <a:ext cx="629788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86" b="1" dirty="0" smtClean="0"/>
              <a:t>Merge</a:t>
            </a:r>
            <a:endParaRPr lang="en-GB" sz="1286" b="1" dirty="0"/>
          </a:p>
        </p:txBody>
      </p:sp>
      <p:sp>
        <p:nvSpPr>
          <p:cNvPr id="39" name="Rectangle 38"/>
          <p:cNvSpPr/>
          <p:nvPr/>
        </p:nvSpPr>
        <p:spPr>
          <a:xfrm>
            <a:off x="93933" y="64398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287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37"/>
          <p:cNvSpPr>
            <a:spLocks noChangeArrowheads="1"/>
          </p:cNvSpPr>
          <p:nvPr/>
        </p:nvSpPr>
        <p:spPr bwMode="auto">
          <a:xfrm>
            <a:off x="4537846" y="1671355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Rectangle 38"/>
          <p:cNvSpPr>
            <a:spLocks noChangeArrowheads="1"/>
          </p:cNvSpPr>
          <p:nvPr/>
        </p:nvSpPr>
        <p:spPr bwMode="auto">
          <a:xfrm>
            <a:off x="4293096" y="1457718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37"/>
          <p:cNvSpPr>
            <a:spLocks noChangeArrowheads="1"/>
          </p:cNvSpPr>
          <p:nvPr/>
        </p:nvSpPr>
        <p:spPr bwMode="auto">
          <a:xfrm>
            <a:off x="2586341" y="1234539"/>
            <a:ext cx="464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Rectangle 38"/>
          <p:cNvSpPr>
            <a:spLocks noChangeArrowheads="1"/>
          </p:cNvSpPr>
          <p:nvPr/>
        </p:nvSpPr>
        <p:spPr bwMode="auto">
          <a:xfrm>
            <a:off x="2370677" y="1019029"/>
            <a:ext cx="684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ectangle 38"/>
          <p:cNvSpPr>
            <a:spLocks noChangeArrowheads="1"/>
          </p:cNvSpPr>
          <p:nvPr/>
        </p:nvSpPr>
        <p:spPr bwMode="auto">
          <a:xfrm>
            <a:off x="4303412" y="3325975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ectangle 37"/>
          <p:cNvSpPr>
            <a:spLocks noChangeArrowheads="1"/>
          </p:cNvSpPr>
          <p:nvPr/>
        </p:nvSpPr>
        <p:spPr bwMode="auto">
          <a:xfrm>
            <a:off x="2600362" y="3556492"/>
            <a:ext cx="464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Rectangle 38"/>
          <p:cNvSpPr>
            <a:spLocks noChangeArrowheads="1"/>
          </p:cNvSpPr>
          <p:nvPr/>
        </p:nvSpPr>
        <p:spPr bwMode="auto">
          <a:xfrm>
            <a:off x="2375557" y="309685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193568" y="498592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193568" y="2647631"/>
            <a:ext cx="228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227282" y="4853041"/>
            <a:ext cx="2317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4" name="Rectangle 73"/>
          <p:cNvSpPr/>
          <p:nvPr/>
        </p:nvSpPr>
        <p:spPr>
          <a:xfrm>
            <a:off x="108124" y="95997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830953" y="1187624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NFE2L2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881172" y="300905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NQO1</a:t>
            </a:r>
          </a:p>
        </p:txBody>
      </p:sp>
      <p:sp>
        <p:nvSpPr>
          <p:cNvPr id="51" name="Rectangle 37"/>
          <p:cNvSpPr>
            <a:spLocks noChangeArrowheads="1"/>
          </p:cNvSpPr>
          <p:nvPr/>
        </p:nvSpPr>
        <p:spPr bwMode="auto">
          <a:xfrm>
            <a:off x="4515850" y="5643072"/>
            <a:ext cx="464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b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38"/>
          <p:cNvSpPr>
            <a:spLocks noChangeArrowheads="1"/>
          </p:cNvSpPr>
          <p:nvPr/>
        </p:nvSpPr>
        <p:spPr bwMode="auto">
          <a:xfrm>
            <a:off x="4304374" y="5517241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37"/>
          <p:cNvSpPr>
            <a:spLocks noChangeArrowheads="1"/>
          </p:cNvSpPr>
          <p:nvPr/>
        </p:nvSpPr>
        <p:spPr bwMode="auto">
          <a:xfrm>
            <a:off x="2585151" y="5491727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Rectangle 38"/>
          <p:cNvSpPr>
            <a:spLocks noChangeArrowheads="1"/>
          </p:cNvSpPr>
          <p:nvPr/>
        </p:nvSpPr>
        <p:spPr bwMode="auto">
          <a:xfrm>
            <a:off x="2377610" y="5489105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2860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743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200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657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853395" y="5196518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GSTA1</a:t>
            </a:r>
          </a:p>
        </p:txBody>
      </p:sp>
      <p:sp>
        <p:nvSpPr>
          <p:cNvPr id="84" name="Rectangle 83"/>
          <p:cNvSpPr/>
          <p:nvPr/>
        </p:nvSpPr>
        <p:spPr>
          <a:xfrm>
            <a:off x="529144" y="7002079"/>
            <a:ext cx="599588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upplementary Figure </a:t>
            </a:r>
            <a:r>
              <a:rPr lang="en-GB" sz="1200" b="1" kern="100" dirty="0" smtClean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S6. </a:t>
            </a:r>
            <a:r>
              <a:rPr lang="en-US" sz="1200" b="1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VBaP</a:t>
            </a:r>
            <a:r>
              <a:rPr lang="en-US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</a:t>
            </a:r>
            <a:r>
              <a:rPr lang="en-GB" sz="12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changes Nrf2 target genes expression. 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NB4, KG1a and HL60 cells were treated as shown for 4 hours before extracting total RNA and synthesising cDNA.  </a:t>
            </a:r>
            <a:r>
              <a:rPr lang="en-GB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qRT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-PCR was performed using gene-specific primers to Nrf2 target genes NFE2L2 (Nrf2), NAD(P)H dehydrogenase -</a:t>
            </a:r>
            <a:r>
              <a:rPr lang="en-GB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quinone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1 (NQO1) and Glutathione S-transferase A1 (GSTA1) expression. Data are normalized using levels of 18s mRNA and are shown as means ± SEM from n=3 experiments. Different letters indicate significant difference from other treatment groups (p&lt;0.05). Abbreviations: vehicle control (CON), 0.6mM Valproic acid (VAL), 0.5 </a:t>
            </a:r>
            <a:r>
              <a:rPr lang="en-GB" sz="1200" kern="100" dirty="0" err="1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M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BEZ and 5</a:t>
            </a:r>
            <a:r>
              <a:rPr lang="el-GR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μ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 MPA (BaP 0.5mM), 0.1mM BEZ and 5</a:t>
            </a:r>
            <a:r>
              <a:rPr lang="el-GR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μ</a:t>
            </a:r>
            <a:r>
              <a:rPr lang="en-GB" sz="1200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M MPA (BaP 0.1mM), the combination of Valproic acid 0.6mM and BaP 0.1mM (VBaP).</a:t>
            </a:r>
            <a:endParaRPr lang="en-GB" sz="1200" kern="100" dirty="0">
              <a:latin typeface="DengXian"/>
              <a:ea typeface="DengXian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4E519092-927D-4EC0-BA3E-C652FD6952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4222563"/>
              </p:ext>
            </p:extLst>
          </p:nvPr>
        </p:nvGraphicFramePr>
        <p:xfrm>
          <a:off x="1559769" y="798865"/>
          <a:ext cx="1455851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" name="Prism 8" r:id="rId4" imgW="3494397" imgH="4665435" progId="Prism8.Document">
                  <p:embed/>
                </p:oleObj>
              </mc:Choice>
              <mc:Fallback>
                <p:oleObj name="Prism 8" r:id="rId4" imgW="3494397" imgH="46654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59769" y="798865"/>
                        <a:ext cx="1455851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AD2DB785-97D1-47B7-966B-D99499D0AE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046404"/>
              </p:ext>
            </p:extLst>
          </p:nvPr>
        </p:nvGraphicFramePr>
        <p:xfrm>
          <a:off x="3499586" y="798865"/>
          <a:ext cx="1455850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" name="Prism 8" r:id="rId6" imgW="3494397" imgH="4665435" progId="Prism8.Document">
                  <p:embed/>
                </p:oleObj>
              </mc:Choice>
              <mc:Fallback>
                <p:oleObj name="Prism 8" r:id="rId6" imgW="3494397" imgH="46654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99586" y="798865"/>
                        <a:ext cx="1455850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991AF160-D407-4FDE-A72C-DC66FF9E44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5353255"/>
              </p:ext>
            </p:extLst>
          </p:nvPr>
        </p:nvGraphicFramePr>
        <p:xfrm>
          <a:off x="1559770" y="2786130"/>
          <a:ext cx="1455850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" name="Prism 8" r:id="rId8" imgW="3494397" imgH="4665435" progId="Prism8.Document">
                  <p:embed/>
                </p:oleObj>
              </mc:Choice>
              <mc:Fallback>
                <p:oleObj name="Prism 8" r:id="rId8" imgW="3494397" imgH="46654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59770" y="2786130"/>
                        <a:ext cx="1455850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E55EDA4A-5BF7-4C3B-A163-4F9CB0599A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3632769"/>
              </p:ext>
            </p:extLst>
          </p:nvPr>
        </p:nvGraphicFramePr>
        <p:xfrm>
          <a:off x="3494964" y="2786130"/>
          <a:ext cx="1455850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1" name="Prism 8" r:id="rId10" imgW="3494397" imgH="4665435" progId="Prism8.Document">
                  <p:embed/>
                </p:oleObj>
              </mc:Choice>
              <mc:Fallback>
                <p:oleObj name="Prism 8" r:id="rId10" imgW="3494397" imgH="46654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94964" y="2786130"/>
                        <a:ext cx="1455850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B658042A-597E-4BF7-A7DA-949709ECAA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2164810"/>
              </p:ext>
            </p:extLst>
          </p:nvPr>
        </p:nvGraphicFramePr>
        <p:xfrm>
          <a:off x="1559769" y="4773395"/>
          <a:ext cx="1455355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2" name="Prism 8" r:id="rId12" imgW="3494397" imgH="4666876" progId="Prism8.Document">
                  <p:embed/>
                </p:oleObj>
              </mc:Choice>
              <mc:Fallback>
                <p:oleObj name="Prism 8" r:id="rId12" imgW="3494397" imgH="466687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559769" y="4773395"/>
                        <a:ext cx="1455355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1401A63D-FAFC-48D1-9F04-702B1A67E9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0952578"/>
              </p:ext>
            </p:extLst>
          </p:nvPr>
        </p:nvGraphicFramePr>
        <p:xfrm>
          <a:off x="3494964" y="4833317"/>
          <a:ext cx="1455850" cy="194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3" name="Prism 8" r:id="rId14" imgW="3494397" imgH="4665435" progId="Prism8.Document">
                  <p:embed/>
                </p:oleObj>
              </mc:Choice>
              <mc:Fallback>
                <p:oleObj name="Prism 8" r:id="rId14" imgW="3494397" imgH="46654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494964" y="4833317"/>
                        <a:ext cx="1455850" cy="194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5228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2</TotalTime>
  <Words>1336</Words>
  <Application>Microsoft Office PowerPoint</Application>
  <PresentationFormat>On-screen Show (4:3)</PresentationFormat>
  <Paragraphs>128</Paragraphs>
  <Slides>6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ＭＳ Ｐゴシック</vt:lpstr>
      <vt:lpstr>宋体</vt:lpstr>
      <vt:lpstr>Arial</vt:lpstr>
      <vt:lpstr>Calibri</vt:lpstr>
      <vt:lpstr>DengXian</vt:lpstr>
      <vt:lpstr>Symbol</vt:lpstr>
      <vt:lpstr>Times New Roman</vt:lpstr>
      <vt:lpstr>Office Theme</vt:lpstr>
      <vt:lpstr>Prism 8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Bunce</dc:creator>
  <cp:lastModifiedBy>Farhat Khanim (Biomedical Sciences)</cp:lastModifiedBy>
  <cp:revision>28</cp:revision>
  <dcterms:created xsi:type="dcterms:W3CDTF">2020-02-27T15:44:26Z</dcterms:created>
  <dcterms:modified xsi:type="dcterms:W3CDTF">2021-08-27T10:33:44Z</dcterms:modified>
</cp:coreProperties>
</file>